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61" r:id="rId2"/>
    <p:sldId id="262" r:id="rId3"/>
    <p:sldId id="257" r:id="rId4"/>
    <p:sldId id="258" r:id="rId5"/>
    <p:sldId id="259" r:id="rId6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8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552" y="1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akagawa\Desktop\CRC%20germline%20manuscipt%20v0.2\variant%20nnmbe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akagawa\Desktop\CRC%20germline%20manuscipt%20v0.2\variant%20nnmber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pathogenic 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A$2:$A$28</c:f>
              <c:strCache>
                <c:ptCount val="27"/>
                <c:pt idx="0">
                  <c:v>BRCA2</c:v>
                </c:pt>
                <c:pt idx="1">
                  <c:v>APC</c:v>
                </c:pt>
                <c:pt idx="2">
                  <c:v>ATM</c:v>
                </c:pt>
                <c:pt idx="3">
                  <c:v>MSH6</c:v>
                </c:pt>
                <c:pt idx="4">
                  <c:v>NF1</c:v>
                </c:pt>
                <c:pt idx="5">
                  <c:v>BRCA1</c:v>
                </c:pt>
                <c:pt idx="6">
                  <c:v>MSH2</c:v>
                </c:pt>
                <c:pt idx="7">
                  <c:v>PALB2</c:v>
                </c:pt>
                <c:pt idx="8">
                  <c:v>BRIP1</c:v>
                </c:pt>
                <c:pt idx="9">
                  <c:v>CDH1</c:v>
                </c:pt>
                <c:pt idx="10">
                  <c:v>MLH1</c:v>
                </c:pt>
                <c:pt idx="11">
                  <c:v>BARD1</c:v>
                </c:pt>
                <c:pt idx="12">
                  <c:v>MUTYH</c:v>
                </c:pt>
                <c:pt idx="13">
                  <c:v>NBN</c:v>
                </c:pt>
                <c:pt idx="14">
                  <c:v>STK11</c:v>
                </c:pt>
                <c:pt idx="15">
                  <c:v>CHEK2</c:v>
                </c:pt>
                <c:pt idx="16">
                  <c:v>EPCAM</c:v>
                </c:pt>
                <c:pt idx="17">
                  <c:v>RAD51C</c:v>
                </c:pt>
                <c:pt idx="18">
                  <c:v>RAD51D</c:v>
                </c:pt>
                <c:pt idx="19">
                  <c:v>TP53</c:v>
                </c:pt>
                <c:pt idx="20">
                  <c:v>PMS2</c:v>
                </c:pt>
                <c:pt idx="21">
                  <c:v>BMPR1A</c:v>
                </c:pt>
                <c:pt idx="22">
                  <c:v>SMAD4</c:v>
                </c:pt>
                <c:pt idx="23">
                  <c:v>HOXB13</c:v>
                </c:pt>
                <c:pt idx="24">
                  <c:v>CDKN2A</c:v>
                </c:pt>
                <c:pt idx="25">
                  <c:v>CDK4</c:v>
                </c:pt>
                <c:pt idx="26">
                  <c:v>PTEN</c:v>
                </c:pt>
              </c:strCache>
            </c:strRef>
          </c:cat>
          <c:val>
            <c:numRef>
              <c:f>Sheet1!$B$2:$B$28</c:f>
              <c:numCache>
                <c:formatCode>General</c:formatCode>
                <c:ptCount val="27"/>
                <c:pt idx="0">
                  <c:v>39</c:v>
                </c:pt>
                <c:pt idx="1">
                  <c:v>20</c:v>
                </c:pt>
                <c:pt idx="2">
                  <c:v>46</c:v>
                </c:pt>
                <c:pt idx="3">
                  <c:v>39</c:v>
                </c:pt>
                <c:pt idx="4">
                  <c:v>15</c:v>
                </c:pt>
                <c:pt idx="5">
                  <c:v>21</c:v>
                </c:pt>
                <c:pt idx="6">
                  <c:v>36</c:v>
                </c:pt>
                <c:pt idx="7">
                  <c:v>15</c:v>
                </c:pt>
                <c:pt idx="8">
                  <c:v>18</c:v>
                </c:pt>
                <c:pt idx="9">
                  <c:v>3</c:v>
                </c:pt>
                <c:pt idx="10">
                  <c:v>35</c:v>
                </c:pt>
                <c:pt idx="11">
                  <c:v>10</c:v>
                </c:pt>
                <c:pt idx="12">
                  <c:v>13</c:v>
                </c:pt>
                <c:pt idx="13">
                  <c:v>11</c:v>
                </c:pt>
                <c:pt idx="14">
                  <c:v>3</c:v>
                </c:pt>
                <c:pt idx="15">
                  <c:v>15</c:v>
                </c:pt>
                <c:pt idx="16">
                  <c:v>8</c:v>
                </c:pt>
                <c:pt idx="17">
                  <c:v>8</c:v>
                </c:pt>
                <c:pt idx="18">
                  <c:v>7</c:v>
                </c:pt>
                <c:pt idx="19">
                  <c:v>19</c:v>
                </c:pt>
                <c:pt idx="20">
                  <c:v>8</c:v>
                </c:pt>
                <c:pt idx="21">
                  <c:v>0</c:v>
                </c:pt>
                <c:pt idx="22">
                  <c:v>1</c:v>
                </c:pt>
                <c:pt idx="23">
                  <c:v>2</c:v>
                </c:pt>
                <c:pt idx="24">
                  <c:v>0</c:v>
                </c:pt>
                <c:pt idx="25">
                  <c:v>0</c:v>
                </c:pt>
                <c:pt idx="26">
                  <c:v>5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VUS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A$2:$A$28</c:f>
              <c:strCache>
                <c:ptCount val="27"/>
                <c:pt idx="0">
                  <c:v>BRCA2</c:v>
                </c:pt>
                <c:pt idx="1">
                  <c:v>APC</c:v>
                </c:pt>
                <c:pt idx="2">
                  <c:v>ATM</c:v>
                </c:pt>
                <c:pt idx="3">
                  <c:v>MSH6</c:v>
                </c:pt>
                <c:pt idx="4">
                  <c:v>NF1</c:v>
                </c:pt>
                <c:pt idx="5">
                  <c:v>BRCA1</c:v>
                </c:pt>
                <c:pt idx="6">
                  <c:v>MSH2</c:v>
                </c:pt>
                <c:pt idx="7">
                  <c:v>PALB2</c:v>
                </c:pt>
                <c:pt idx="8">
                  <c:v>BRIP1</c:v>
                </c:pt>
                <c:pt idx="9">
                  <c:v>CDH1</c:v>
                </c:pt>
                <c:pt idx="10">
                  <c:v>MLH1</c:v>
                </c:pt>
                <c:pt idx="11">
                  <c:v>BARD1</c:v>
                </c:pt>
                <c:pt idx="12">
                  <c:v>MUTYH</c:v>
                </c:pt>
                <c:pt idx="13">
                  <c:v>NBN</c:v>
                </c:pt>
                <c:pt idx="14">
                  <c:v>STK11</c:v>
                </c:pt>
                <c:pt idx="15">
                  <c:v>CHEK2</c:v>
                </c:pt>
                <c:pt idx="16">
                  <c:v>EPCAM</c:v>
                </c:pt>
                <c:pt idx="17">
                  <c:v>RAD51C</c:v>
                </c:pt>
                <c:pt idx="18">
                  <c:v>RAD51D</c:v>
                </c:pt>
                <c:pt idx="19">
                  <c:v>TP53</c:v>
                </c:pt>
                <c:pt idx="20">
                  <c:v>PMS2</c:v>
                </c:pt>
                <c:pt idx="21">
                  <c:v>BMPR1A</c:v>
                </c:pt>
                <c:pt idx="22">
                  <c:v>SMAD4</c:v>
                </c:pt>
                <c:pt idx="23">
                  <c:v>HOXB13</c:v>
                </c:pt>
                <c:pt idx="24">
                  <c:v>CDKN2A</c:v>
                </c:pt>
                <c:pt idx="25">
                  <c:v>CDK4</c:v>
                </c:pt>
                <c:pt idx="26">
                  <c:v>PTEN</c:v>
                </c:pt>
              </c:strCache>
            </c:strRef>
          </c:cat>
          <c:val>
            <c:numRef>
              <c:f>Sheet1!$C$2:$C$28</c:f>
              <c:numCache>
                <c:formatCode>General</c:formatCode>
                <c:ptCount val="27"/>
                <c:pt idx="0">
                  <c:v>369</c:v>
                </c:pt>
                <c:pt idx="1">
                  <c:v>394</c:v>
                </c:pt>
                <c:pt idx="2">
                  <c:v>331</c:v>
                </c:pt>
                <c:pt idx="3">
                  <c:v>244</c:v>
                </c:pt>
                <c:pt idx="4">
                  <c:v>242</c:v>
                </c:pt>
                <c:pt idx="5">
                  <c:v>180</c:v>
                </c:pt>
                <c:pt idx="6">
                  <c:v>160</c:v>
                </c:pt>
                <c:pt idx="7">
                  <c:v>153</c:v>
                </c:pt>
                <c:pt idx="8">
                  <c:v>141</c:v>
                </c:pt>
                <c:pt idx="9">
                  <c:v>126</c:v>
                </c:pt>
                <c:pt idx="10">
                  <c:v>112</c:v>
                </c:pt>
                <c:pt idx="11">
                  <c:v>118</c:v>
                </c:pt>
                <c:pt idx="12">
                  <c:v>98</c:v>
                </c:pt>
                <c:pt idx="13">
                  <c:v>85</c:v>
                </c:pt>
                <c:pt idx="14">
                  <c:v>72</c:v>
                </c:pt>
                <c:pt idx="15">
                  <c:v>70</c:v>
                </c:pt>
                <c:pt idx="16">
                  <c:v>66</c:v>
                </c:pt>
                <c:pt idx="17">
                  <c:v>66</c:v>
                </c:pt>
                <c:pt idx="18">
                  <c:v>52</c:v>
                </c:pt>
                <c:pt idx="19">
                  <c:v>47</c:v>
                </c:pt>
                <c:pt idx="20">
                  <c:v>55</c:v>
                </c:pt>
                <c:pt idx="21">
                  <c:v>56</c:v>
                </c:pt>
                <c:pt idx="22">
                  <c:v>49</c:v>
                </c:pt>
                <c:pt idx="23">
                  <c:v>54</c:v>
                </c:pt>
                <c:pt idx="24">
                  <c:v>44</c:v>
                </c:pt>
                <c:pt idx="25">
                  <c:v>38</c:v>
                </c:pt>
                <c:pt idx="26">
                  <c:v>34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benig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2:$A$28</c:f>
              <c:strCache>
                <c:ptCount val="27"/>
                <c:pt idx="0">
                  <c:v>BRCA2</c:v>
                </c:pt>
                <c:pt idx="1">
                  <c:v>APC</c:v>
                </c:pt>
                <c:pt idx="2">
                  <c:v>ATM</c:v>
                </c:pt>
                <c:pt idx="3">
                  <c:v>MSH6</c:v>
                </c:pt>
                <c:pt idx="4">
                  <c:v>NF1</c:v>
                </c:pt>
                <c:pt idx="5">
                  <c:v>BRCA1</c:v>
                </c:pt>
                <c:pt idx="6">
                  <c:v>MSH2</c:v>
                </c:pt>
                <c:pt idx="7">
                  <c:v>PALB2</c:v>
                </c:pt>
                <c:pt idx="8">
                  <c:v>BRIP1</c:v>
                </c:pt>
                <c:pt idx="9">
                  <c:v>CDH1</c:v>
                </c:pt>
                <c:pt idx="10">
                  <c:v>MLH1</c:v>
                </c:pt>
                <c:pt idx="11">
                  <c:v>BARD1</c:v>
                </c:pt>
                <c:pt idx="12">
                  <c:v>MUTYH</c:v>
                </c:pt>
                <c:pt idx="13">
                  <c:v>NBN</c:v>
                </c:pt>
                <c:pt idx="14">
                  <c:v>STK11</c:v>
                </c:pt>
                <c:pt idx="15">
                  <c:v>CHEK2</c:v>
                </c:pt>
                <c:pt idx="16">
                  <c:v>EPCAM</c:v>
                </c:pt>
                <c:pt idx="17">
                  <c:v>RAD51C</c:v>
                </c:pt>
                <c:pt idx="18">
                  <c:v>RAD51D</c:v>
                </c:pt>
                <c:pt idx="19">
                  <c:v>TP53</c:v>
                </c:pt>
                <c:pt idx="20">
                  <c:v>PMS2</c:v>
                </c:pt>
                <c:pt idx="21">
                  <c:v>BMPR1A</c:v>
                </c:pt>
                <c:pt idx="22">
                  <c:v>SMAD4</c:v>
                </c:pt>
                <c:pt idx="23">
                  <c:v>HOXB13</c:v>
                </c:pt>
                <c:pt idx="24">
                  <c:v>CDKN2A</c:v>
                </c:pt>
                <c:pt idx="25">
                  <c:v>CDK4</c:v>
                </c:pt>
                <c:pt idx="26">
                  <c:v>PTEN</c:v>
                </c:pt>
              </c:strCache>
            </c:strRef>
          </c:cat>
          <c:val>
            <c:numRef>
              <c:f>Sheet1!$D$2:$D$28</c:f>
              <c:numCache>
                <c:formatCode>General</c:formatCode>
                <c:ptCount val="27"/>
                <c:pt idx="0">
                  <c:v>140</c:v>
                </c:pt>
                <c:pt idx="1">
                  <c:v>71</c:v>
                </c:pt>
                <c:pt idx="2">
                  <c:v>89</c:v>
                </c:pt>
                <c:pt idx="3">
                  <c:v>51</c:v>
                </c:pt>
                <c:pt idx="4">
                  <c:v>75</c:v>
                </c:pt>
                <c:pt idx="5">
                  <c:v>79</c:v>
                </c:pt>
                <c:pt idx="6">
                  <c:v>39</c:v>
                </c:pt>
                <c:pt idx="7">
                  <c:v>40</c:v>
                </c:pt>
                <c:pt idx="8">
                  <c:v>32</c:v>
                </c:pt>
                <c:pt idx="9">
                  <c:v>48</c:v>
                </c:pt>
                <c:pt idx="10">
                  <c:v>21</c:v>
                </c:pt>
                <c:pt idx="11">
                  <c:v>31</c:v>
                </c:pt>
                <c:pt idx="12">
                  <c:v>15</c:v>
                </c:pt>
                <c:pt idx="13">
                  <c:v>29</c:v>
                </c:pt>
                <c:pt idx="14">
                  <c:v>30</c:v>
                </c:pt>
                <c:pt idx="15">
                  <c:v>15</c:v>
                </c:pt>
                <c:pt idx="16">
                  <c:v>12</c:v>
                </c:pt>
                <c:pt idx="17">
                  <c:v>11</c:v>
                </c:pt>
                <c:pt idx="18">
                  <c:v>25</c:v>
                </c:pt>
                <c:pt idx="19">
                  <c:v>18</c:v>
                </c:pt>
                <c:pt idx="20">
                  <c:v>10</c:v>
                </c:pt>
                <c:pt idx="21">
                  <c:v>15</c:v>
                </c:pt>
                <c:pt idx="22">
                  <c:v>13</c:v>
                </c:pt>
                <c:pt idx="23">
                  <c:v>5</c:v>
                </c:pt>
                <c:pt idx="24">
                  <c:v>12</c:v>
                </c:pt>
                <c:pt idx="25">
                  <c:v>8</c:v>
                </c:pt>
                <c:pt idx="26">
                  <c:v>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49690920"/>
        <c:axId val="349705424"/>
      </c:barChart>
      <c:catAx>
        <c:axId val="349690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49705424"/>
        <c:crosses val="autoZero"/>
        <c:auto val="1"/>
        <c:lblAlgn val="ctr"/>
        <c:lblOffset val="100"/>
        <c:noMultiLvlLbl val="0"/>
      </c:catAx>
      <c:valAx>
        <c:axId val="349705424"/>
        <c:scaling>
          <c:orientation val="minMax"/>
          <c:max val="6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49690920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6410433804288852"/>
          <c:y val="4.1251222843195177E-2"/>
          <c:w val="0.60578927634045732"/>
          <c:h val="0.2453446505720548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4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B$2:$B$28</c:f>
              <c:strCache>
                <c:ptCount val="27"/>
                <c:pt idx="0">
                  <c:v>EPCAM</c:v>
                </c:pt>
                <c:pt idx="1">
                  <c:v>MSH2</c:v>
                </c:pt>
                <c:pt idx="2">
                  <c:v>MSH6</c:v>
                </c:pt>
                <c:pt idx="3">
                  <c:v>STK11</c:v>
                </c:pt>
                <c:pt idx="4">
                  <c:v>CDKN2A</c:v>
                </c:pt>
                <c:pt idx="5">
                  <c:v>MUTYH</c:v>
                </c:pt>
                <c:pt idx="6">
                  <c:v>RAD51C</c:v>
                </c:pt>
                <c:pt idx="7">
                  <c:v>MLH1</c:v>
                </c:pt>
                <c:pt idx="8">
                  <c:v>PMS2</c:v>
                </c:pt>
                <c:pt idx="9">
                  <c:v>HOXB13</c:v>
                </c:pt>
                <c:pt idx="10">
                  <c:v>RAD51D</c:v>
                </c:pt>
                <c:pt idx="11">
                  <c:v>BARD1</c:v>
                </c:pt>
                <c:pt idx="12">
                  <c:v>CDH1</c:v>
                </c:pt>
                <c:pt idx="13">
                  <c:v>TP53</c:v>
                </c:pt>
                <c:pt idx="14">
                  <c:v>PALB2</c:v>
                </c:pt>
                <c:pt idx="15">
                  <c:v>APC</c:v>
                </c:pt>
                <c:pt idx="16">
                  <c:v>CHEK2</c:v>
                </c:pt>
                <c:pt idx="17">
                  <c:v>NBN</c:v>
                </c:pt>
                <c:pt idx="18">
                  <c:v>BRCA2</c:v>
                </c:pt>
                <c:pt idx="19">
                  <c:v>BRIP1</c:v>
                </c:pt>
                <c:pt idx="20">
                  <c:v>ATM</c:v>
                </c:pt>
                <c:pt idx="21">
                  <c:v>CDK4</c:v>
                </c:pt>
                <c:pt idx="22">
                  <c:v>BRCA1</c:v>
                </c:pt>
                <c:pt idx="23">
                  <c:v>BMPR1A</c:v>
                </c:pt>
                <c:pt idx="24">
                  <c:v>NF1</c:v>
                </c:pt>
                <c:pt idx="25">
                  <c:v>SMAD4</c:v>
                </c:pt>
                <c:pt idx="26">
                  <c:v>PTEN</c:v>
                </c:pt>
              </c:strCache>
            </c:strRef>
          </c:cat>
          <c:val>
            <c:numRef>
              <c:f>Sheet2!$C$2:$C$28</c:f>
              <c:numCache>
                <c:formatCode>General</c:formatCode>
                <c:ptCount val="27"/>
                <c:pt idx="0">
                  <c:v>87.665647298674827</c:v>
                </c:pt>
                <c:pt idx="1">
                  <c:v>81.910073196235629</c:v>
                </c:pt>
                <c:pt idx="2">
                  <c:v>81.008974048023276</c:v>
                </c:pt>
                <c:pt idx="3">
                  <c:v>78.475336322869964</c:v>
                </c:pt>
                <c:pt idx="4">
                  <c:v>76.607387140902873</c:v>
                </c:pt>
                <c:pt idx="5">
                  <c:v>73.900293255131956</c:v>
                </c:pt>
                <c:pt idx="6">
                  <c:v>72.587532023911194</c:v>
                </c:pt>
                <c:pt idx="7">
                  <c:v>71.580741371964208</c:v>
                </c:pt>
                <c:pt idx="8">
                  <c:v>71.2890625</c:v>
                </c:pt>
                <c:pt idx="9">
                  <c:v>70.683661645422944</c:v>
                </c:pt>
                <c:pt idx="10">
                  <c:v>69.421487603305778</c:v>
                </c:pt>
                <c:pt idx="11">
                  <c:v>66.862910008410424</c:v>
                </c:pt>
                <c:pt idx="12">
                  <c:v>65.24143015112422</c:v>
                </c:pt>
                <c:pt idx="13">
                  <c:v>64.073226544622429</c:v>
                </c:pt>
                <c:pt idx="14">
                  <c:v>57.569886520896766</c:v>
                </c:pt>
                <c:pt idx="15">
                  <c:v>56.447858472998135</c:v>
                </c:pt>
                <c:pt idx="16">
                  <c:v>54.914881933003848</c:v>
                </c:pt>
                <c:pt idx="17">
                  <c:v>53.671103477887506</c:v>
                </c:pt>
                <c:pt idx="18">
                  <c:v>52.890647620886014</c:v>
                </c:pt>
                <c:pt idx="19">
                  <c:v>49.921589127025612</c:v>
                </c:pt>
                <c:pt idx="20">
                  <c:v>49.474466503875142</c:v>
                </c:pt>
                <c:pt idx="21">
                  <c:v>48.936170212765958</c:v>
                </c:pt>
                <c:pt idx="22">
                  <c:v>48.695652173913039</c:v>
                </c:pt>
                <c:pt idx="23">
                  <c:v>43.213633597078513</c:v>
                </c:pt>
                <c:pt idx="24">
                  <c:v>37.671621468285487</c:v>
                </c:pt>
                <c:pt idx="25">
                  <c:v>36.9935408103347</c:v>
                </c:pt>
                <c:pt idx="26">
                  <c:v>36.85897435897435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7754280"/>
        <c:axId val="347756632"/>
      </c:barChart>
      <c:catAx>
        <c:axId val="3477542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47756632"/>
        <c:crosses val="autoZero"/>
        <c:auto val="1"/>
        <c:lblAlgn val="ctr"/>
        <c:lblOffset val="100"/>
        <c:noMultiLvlLbl val="0"/>
      </c:catAx>
      <c:valAx>
        <c:axId val="3477566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477542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pathogenic 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A$2:$A$28</c:f>
              <c:strCache>
                <c:ptCount val="27"/>
                <c:pt idx="0">
                  <c:v>APC</c:v>
                </c:pt>
                <c:pt idx="1">
                  <c:v>BRCA2</c:v>
                </c:pt>
                <c:pt idx="2">
                  <c:v>ATM</c:v>
                </c:pt>
                <c:pt idx="3">
                  <c:v>MSH6</c:v>
                </c:pt>
                <c:pt idx="4">
                  <c:v>NF1</c:v>
                </c:pt>
                <c:pt idx="5">
                  <c:v>BRCA1</c:v>
                </c:pt>
                <c:pt idx="6">
                  <c:v>MSH2</c:v>
                </c:pt>
                <c:pt idx="7">
                  <c:v>PALB2</c:v>
                </c:pt>
                <c:pt idx="8">
                  <c:v>BRIP1</c:v>
                </c:pt>
                <c:pt idx="9">
                  <c:v>CDH1</c:v>
                </c:pt>
                <c:pt idx="10">
                  <c:v>MLH1</c:v>
                </c:pt>
                <c:pt idx="11">
                  <c:v>BARD1</c:v>
                </c:pt>
                <c:pt idx="12">
                  <c:v>MUTYH</c:v>
                </c:pt>
                <c:pt idx="13">
                  <c:v>NBN</c:v>
                </c:pt>
                <c:pt idx="14">
                  <c:v>STK11</c:v>
                </c:pt>
                <c:pt idx="15">
                  <c:v>CHEK2</c:v>
                </c:pt>
                <c:pt idx="16">
                  <c:v>EPCAM</c:v>
                </c:pt>
                <c:pt idx="17">
                  <c:v>RAD51C</c:v>
                </c:pt>
                <c:pt idx="18">
                  <c:v>RAD51D</c:v>
                </c:pt>
                <c:pt idx="19">
                  <c:v>TP53</c:v>
                </c:pt>
                <c:pt idx="20">
                  <c:v>PMS2</c:v>
                </c:pt>
                <c:pt idx="21">
                  <c:v>BMPR1A</c:v>
                </c:pt>
                <c:pt idx="22">
                  <c:v>SMAD4</c:v>
                </c:pt>
                <c:pt idx="23">
                  <c:v>HOXB13</c:v>
                </c:pt>
                <c:pt idx="24">
                  <c:v>CDKN2A</c:v>
                </c:pt>
                <c:pt idx="25">
                  <c:v>CDK4</c:v>
                </c:pt>
                <c:pt idx="26">
                  <c:v>PTEN</c:v>
                </c:pt>
              </c:strCache>
            </c:strRef>
          </c:cat>
          <c:val>
            <c:numRef>
              <c:f>Sheet1!$B$2:$B$28</c:f>
              <c:numCache>
                <c:formatCode>General</c:formatCode>
                <c:ptCount val="27"/>
                <c:pt idx="0">
                  <c:v>20</c:v>
                </c:pt>
                <c:pt idx="1">
                  <c:v>39</c:v>
                </c:pt>
                <c:pt idx="2">
                  <c:v>46</c:v>
                </c:pt>
                <c:pt idx="3">
                  <c:v>39</c:v>
                </c:pt>
                <c:pt idx="4">
                  <c:v>15</c:v>
                </c:pt>
                <c:pt idx="5">
                  <c:v>21</c:v>
                </c:pt>
                <c:pt idx="6">
                  <c:v>36</c:v>
                </c:pt>
                <c:pt idx="7">
                  <c:v>15</c:v>
                </c:pt>
                <c:pt idx="8">
                  <c:v>18</c:v>
                </c:pt>
                <c:pt idx="9">
                  <c:v>3</c:v>
                </c:pt>
                <c:pt idx="10">
                  <c:v>35</c:v>
                </c:pt>
                <c:pt idx="11">
                  <c:v>10</c:v>
                </c:pt>
                <c:pt idx="12">
                  <c:v>13</c:v>
                </c:pt>
                <c:pt idx="13">
                  <c:v>11</c:v>
                </c:pt>
                <c:pt idx="14">
                  <c:v>3</c:v>
                </c:pt>
                <c:pt idx="15">
                  <c:v>15</c:v>
                </c:pt>
                <c:pt idx="16">
                  <c:v>8</c:v>
                </c:pt>
                <c:pt idx="17">
                  <c:v>8</c:v>
                </c:pt>
                <c:pt idx="18">
                  <c:v>7</c:v>
                </c:pt>
                <c:pt idx="19">
                  <c:v>19</c:v>
                </c:pt>
                <c:pt idx="20">
                  <c:v>8</c:v>
                </c:pt>
                <c:pt idx="21">
                  <c:v>0</c:v>
                </c:pt>
                <c:pt idx="22">
                  <c:v>1</c:v>
                </c:pt>
                <c:pt idx="23">
                  <c:v>2</c:v>
                </c:pt>
                <c:pt idx="24">
                  <c:v>0</c:v>
                </c:pt>
                <c:pt idx="25">
                  <c:v>0</c:v>
                </c:pt>
                <c:pt idx="26">
                  <c:v>5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VUS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A$2:$A$28</c:f>
              <c:strCache>
                <c:ptCount val="27"/>
                <c:pt idx="0">
                  <c:v>APC</c:v>
                </c:pt>
                <c:pt idx="1">
                  <c:v>BRCA2</c:v>
                </c:pt>
                <c:pt idx="2">
                  <c:v>ATM</c:v>
                </c:pt>
                <c:pt idx="3">
                  <c:v>MSH6</c:v>
                </c:pt>
                <c:pt idx="4">
                  <c:v>NF1</c:v>
                </c:pt>
                <c:pt idx="5">
                  <c:v>BRCA1</c:v>
                </c:pt>
                <c:pt idx="6">
                  <c:v>MSH2</c:v>
                </c:pt>
                <c:pt idx="7">
                  <c:v>PALB2</c:v>
                </c:pt>
                <c:pt idx="8">
                  <c:v>BRIP1</c:v>
                </c:pt>
                <c:pt idx="9">
                  <c:v>CDH1</c:v>
                </c:pt>
                <c:pt idx="10">
                  <c:v>MLH1</c:v>
                </c:pt>
                <c:pt idx="11">
                  <c:v>BARD1</c:v>
                </c:pt>
                <c:pt idx="12">
                  <c:v>MUTYH</c:v>
                </c:pt>
                <c:pt idx="13">
                  <c:v>NBN</c:v>
                </c:pt>
                <c:pt idx="14">
                  <c:v>STK11</c:v>
                </c:pt>
                <c:pt idx="15">
                  <c:v>CHEK2</c:v>
                </c:pt>
                <c:pt idx="16">
                  <c:v>EPCAM</c:v>
                </c:pt>
                <c:pt idx="17">
                  <c:v>RAD51C</c:v>
                </c:pt>
                <c:pt idx="18">
                  <c:v>RAD51D</c:v>
                </c:pt>
                <c:pt idx="19">
                  <c:v>TP53</c:v>
                </c:pt>
                <c:pt idx="20">
                  <c:v>PMS2</c:v>
                </c:pt>
                <c:pt idx="21">
                  <c:v>BMPR1A</c:v>
                </c:pt>
                <c:pt idx="22">
                  <c:v>SMAD4</c:v>
                </c:pt>
                <c:pt idx="23">
                  <c:v>HOXB13</c:v>
                </c:pt>
                <c:pt idx="24">
                  <c:v>CDKN2A</c:v>
                </c:pt>
                <c:pt idx="25">
                  <c:v>CDK4</c:v>
                </c:pt>
                <c:pt idx="26">
                  <c:v>PTEN</c:v>
                </c:pt>
              </c:strCache>
            </c:strRef>
          </c:cat>
          <c:val>
            <c:numRef>
              <c:f>Sheet1!$C$2:$C$28</c:f>
              <c:numCache>
                <c:formatCode>General</c:formatCode>
                <c:ptCount val="27"/>
                <c:pt idx="0">
                  <c:v>2383</c:v>
                </c:pt>
                <c:pt idx="1">
                  <c:v>369</c:v>
                </c:pt>
                <c:pt idx="2">
                  <c:v>331</c:v>
                </c:pt>
                <c:pt idx="3">
                  <c:v>244</c:v>
                </c:pt>
                <c:pt idx="4">
                  <c:v>242</c:v>
                </c:pt>
                <c:pt idx="5">
                  <c:v>180</c:v>
                </c:pt>
                <c:pt idx="6">
                  <c:v>160</c:v>
                </c:pt>
                <c:pt idx="7">
                  <c:v>153</c:v>
                </c:pt>
                <c:pt idx="8">
                  <c:v>141</c:v>
                </c:pt>
                <c:pt idx="9">
                  <c:v>126</c:v>
                </c:pt>
                <c:pt idx="10">
                  <c:v>112</c:v>
                </c:pt>
                <c:pt idx="11">
                  <c:v>118</c:v>
                </c:pt>
                <c:pt idx="12">
                  <c:v>98</c:v>
                </c:pt>
                <c:pt idx="13">
                  <c:v>85</c:v>
                </c:pt>
                <c:pt idx="14">
                  <c:v>72</c:v>
                </c:pt>
                <c:pt idx="15">
                  <c:v>70</c:v>
                </c:pt>
                <c:pt idx="16">
                  <c:v>66</c:v>
                </c:pt>
                <c:pt idx="17">
                  <c:v>66</c:v>
                </c:pt>
                <c:pt idx="18">
                  <c:v>52</c:v>
                </c:pt>
                <c:pt idx="19">
                  <c:v>47</c:v>
                </c:pt>
                <c:pt idx="20">
                  <c:v>55</c:v>
                </c:pt>
                <c:pt idx="21">
                  <c:v>56</c:v>
                </c:pt>
                <c:pt idx="22">
                  <c:v>49</c:v>
                </c:pt>
                <c:pt idx="23">
                  <c:v>54</c:v>
                </c:pt>
                <c:pt idx="24">
                  <c:v>44</c:v>
                </c:pt>
                <c:pt idx="25">
                  <c:v>38</c:v>
                </c:pt>
                <c:pt idx="26">
                  <c:v>34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benig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2:$A$28</c:f>
              <c:strCache>
                <c:ptCount val="27"/>
                <c:pt idx="0">
                  <c:v>APC</c:v>
                </c:pt>
                <c:pt idx="1">
                  <c:v>BRCA2</c:v>
                </c:pt>
                <c:pt idx="2">
                  <c:v>ATM</c:v>
                </c:pt>
                <c:pt idx="3">
                  <c:v>MSH6</c:v>
                </c:pt>
                <c:pt idx="4">
                  <c:v>NF1</c:v>
                </c:pt>
                <c:pt idx="5">
                  <c:v>BRCA1</c:v>
                </c:pt>
                <c:pt idx="6">
                  <c:v>MSH2</c:v>
                </c:pt>
                <c:pt idx="7">
                  <c:v>PALB2</c:v>
                </c:pt>
                <c:pt idx="8">
                  <c:v>BRIP1</c:v>
                </c:pt>
                <c:pt idx="9">
                  <c:v>CDH1</c:v>
                </c:pt>
                <c:pt idx="10">
                  <c:v>MLH1</c:v>
                </c:pt>
                <c:pt idx="11">
                  <c:v>BARD1</c:v>
                </c:pt>
                <c:pt idx="12">
                  <c:v>MUTYH</c:v>
                </c:pt>
                <c:pt idx="13">
                  <c:v>NBN</c:v>
                </c:pt>
                <c:pt idx="14">
                  <c:v>STK11</c:v>
                </c:pt>
                <c:pt idx="15">
                  <c:v>CHEK2</c:v>
                </c:pt>
                <c:pt idx="16">
                  <c:v>EPCAM</c:v>
                </c:pt>
                <c:pt idx="17">
                  <c:v>RAD51C</c:v>
                </c:pt>
                <c:pt idx="18">
                  <c:v>RAD51D</c:v>
                </c:pt>
                <c:pt idx="19">
                  <c:v>TP53</c:v>
                </c:pt>
                <c:pt idx="20">
                  <c:v>PMS2</c:v>
                </c:pt>
                <c:pt idx="21">
                  <c:v>BMPR1A</c:v>
                </c:pt>
                <c:pt idx="22">
                  <c:v>SMAD4</c:v>
                </c:pt>
                <c:pt idx="23">
                  <c:v>HOXB13</c:v>
                </c:pt>
                <c:pt idx="24">
                  <c:v>CDKN2A</c:v>
                </c:pt>
                <c:pt idx="25">
                  <c:v>CDK4</c:v>
                </c:pt>
                <c:pt idx="26">
                  <c:v>PTEN</c:v>
                </c:pt>
              </c:strCache>
            </c:strRef>
          </c:cat>
          <c:val>
            <c:numRef>
              <c:f>Sheet1!$D$2:$D$28</c:f>
              <c:numCache>
                <c:formatCode>General</c:formatCode>
                <c:ptCount val="27"/>
                <c:pt idx="0">
                  <c:v>71</c:v>
                </c:pt>
                <c:pt idx="1">
                  <c:v>140</c:v>
                </c:pt>
                <c:pt idx="2">
                  <c:v>89</c:v>
                </c:pt>
                <c:pt idx="3">
                  <c:v>51</c:v>
                </c:pt>
                <c:pt idx="4">
                  <c:v>75</c:v>
                </c:pt>
                <c:pt idx="5">
                  <c:v>79</c:v>
                </c:pt>
                <c:pt idx="6">
                  <c:v>39</c:v>
                </c:pt>
                <c:pt idx="7">
                  <c:v>40</c:v>
                </c:pt>
                <c:pt idx="8">
                  <c:v>32</c:v>
                </c:pt>
                <c:pt idx="9">
                  <c:v>48</c:v>
                </c:pt>
                <c:pt idx="10">
                  <c:v>21</c:v>
                </c:pt>
                <c:pt idx="11">
                  <c:v>31</c:v>
                </c:pt>
                <c:pt idx="12">
                  <c:v>15</c:v>
                </c:pt>
                <c:pt idx="13">
                  <c:v>29</c:v>
                </c:pt>
                <c:pt idx="14">
                  <c:v>30</c:v>
                </c:pt>
                <c:pt idx="15">
                  <c:v>15</c:v>
                </c:pt>
                <c:pt idx="16">
                  <c:v>12</c:v>
                </c:pt>
                <c:pt idx="17">
                  <c:v>11</c:v>
                </c:pt>
                <c:pt idx="18">
                  <c:v>25</c:v>
                </c:pt>
                <c:pt idx="19">
                  <c:v>18</c:v>
                </c:pt>
                <c:pt idx="20">
                  <c:v>10</c:v>
                </c:pt>
                <c:pt idx="21">
                  <c:v>15</c:v>
                </c:pt>
                <c:pt idx="22">
                  <c:v>13</c:v>
                </c:pt>
                <c:pt idx="23">
                  <c:v>5</c:v>
                </c:pt>
                <c:pt idx="24">
                  <c:v>12</c:v>
                </c:pt>
                <c:pt idx="25">
                  <c:v>8</c:v>
                </c:pt>
                <c:pt idx="26">
                  <c:v>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51487104"/>
        <c:axId val="551484360"/>
      </c:barChart>
      <c:catAx>
        <c:axId val="5514871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51484360"/>
        <c:crosses val="autoZero"/>
        <c:auto val="1"/>
        <c:lblAlgn val="ctr"/>
        <c:lblOffset val="100"/>
        <c:noMultiLvlLbl val="0"/>
      </c:catAx>
      <c:valAx>
        <c:axId val="5514843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514871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481C3D-329F-4E2B-9667-270C22ED6F52}" type="datetimeFigureOut">
              <a:rPr kumimoji="1" lang="ja-JP" altLang="en-US" smtClean="0"/>
              <a:t>2020/1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7DDAD0-D8A3-40A2-9966-777375162A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65243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CD4846A-60D8-4487-9123-525E5AD10325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46116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446C6-86A3-4FA9-9AC4-1823B9D29260}" type="datetimeFigureOut">
              <a:rPr kumimoji="1" lang="ja-JP" altLang="en-US" smtClean="0"/>
              <a:t>2020/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56B42-9BDD-4A86-B58F-EEC3BD5AF3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20220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446C6-86A3-4FA9-9AC4-1823B9D29260}" type="datetimeFigureOut">
              <a:rPr kumimoji="1" lang="ja-JP" altLang="en-US" smtClean="0"/>
              <a:t>2020/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56B42-9BDD-4A86-B58F-EEC3BD5AF3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7719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446C6-86A3-4FA9-9AC4-1823B9D29260}" type="datetimeFigureOut">
              <a:rPr kumimoji="1" lang="ja-JP" altLang="en-US" smtClean="0"/>
              <a:t>2020/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56B42-9BDD-4A86-B58F-EEC3BD5AF3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16364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446C6-86A3-4FA9-9AC4-1823B9D29260}" type="datetimeFigureOut">
              <a:rPr kumimoji="1" lang="ja-JP" altLang="en-US" smtClean="0"/>
              <a:t>2020/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56B42-9BDD-4A86-B58F-EEC3BD5AF3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69491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446C6-86A3-4FA9-9AC4-1823B9D29260}" type="datetimeFigureOut">
              <a:rPr kumimoji="1" lang="ja-JP" altLang="en-US" smtClean="0"/>
              <a:t>2020/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56B42-9BDD-4A86-B58F-EEC3BD5AF3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49097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446C6-86A3-4FA9-9AC4-1823B9D29260}" type="datetimeFigureOut">
              <a:rPr kumimoji="1" lang="ja-JP" altLang="en-US" smtClean="0"/>
              <a:t>2020/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56B42-9BDD-4A86-B58F-EEC3BD5AF3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98364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446C6-86A3-4FA9-9AC4-1823B9D29260}" type="datetimeFigureOut">
              <a:rPr kumimoji="1" lang="ja-JP" altLang="en-US" smtClean="0"/>
              <a:t>2020/1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56B42-9BDD-4A86-B58F-EEC3BD5AF3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19498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446C6-86A3-4FA9-9AC4-1823B9D29260}" type="datetimeFigureOut">
              <a:rPr kumimoji="1" lang="ja-JP" altLang="en-US" smtClean="0"/>
              <a:t>2020/1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56B42-9BDD-4A86-B58F-EEC3BD5AF3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39656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446C6-86A3-4FA9-9AC4-1823B9D29260}" type="datetimeFigureOut">
              <a:rPr kumimoji="1" lang="ja-JP" altLang="en-US" smtClean="0"/>
              <a:t>2020/1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56B42-9BDD-4A86-B58F-EEC3BD5AF3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32274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446C6-86A3-4FA9-9AC4-1823B9D29260}" type="datetimeFigureOut">
              <a:rPr kumimoji="1" lang="ja-JP" altLang="en-US" smtClean="0"/>
              <a:t>2020/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56B42-9BDD-4A86-B58F-EEC3BD5AF3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9674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446C6-86A3-4FA9-9AC4-1823B9D29260}" type="datetimeFigureOut">
              <a:rPr kumimoji="1" lang="ja-JP" altLang="en-US" smtClean="0"/>
              <a:t>2020/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56B42-9BDD-4A86-B58F-EEC3BD5AF3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90646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0446C6-86A3-4FA9-9AC4-1823B9D29260}" type="datetimeFigureOut">
              <a:rPr kumimoji="1" lang="ja-JP" altLang="en-US" smtClean="0"/>
              <a:t>2020/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B56B42-9BDD-4A86-B58F-EEC3BD5AF3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1814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emf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139454" y="498990"/>
            <a:ext cx="436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(a)</a:t>
            </a:r>
            <a:endParaRPr kumimoji="1" lang="ja-JP" altLang="en-US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28246" y="3128963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(b)</a:t>
            </a:r>
            <a:endParaRPr kumimoji="1" lang="ja-JP" altLang="en-US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1434" y="0"/>
            <a:ext cx="2537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Supplementary Fig. 1</a:t>
            </a:r>
            <a:endParaRPr kumimoji="1" lang="ja-JP" altLang="en-US" dirty="0"/>
          </a:p>
        </p:txBody>
      </p:sp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00947580"/>
              </p:ext>
            </p:extLst>
          </p:nvPr>
        </p:nvGraphicFramePr>
        <p:xfrm>
          <a:off x="953689" y="534708"/>
          <a:ext cx="7304486" cy="30895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グラフ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23873061"/>
              </p:ext>
            </p:extLst>
          </p:nvPr>
        </p:nvGraphicFramePr>
        <p:xfrm>
          <a:off x="1034054" y="3624272"/>
          <a:ext cx="7152683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テキスト ボックス 3"/>
          <p:cNvSpPr txBox="1"/>
          <p:nvPr/>
        </p:nvSpPr>
        <p:spPr>
          <a:xfrm rot="16200000">
            <a:off x="-12011" y="1553497"/>
            <a:ext cx="1276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Variants numbers</a:t>
            </a:r>
            <a:endParaRPr kumimoji="1" lang="ja-JP" altLang="en-US" sz="1200" dirty="0"/>
          </a:p>
        </p:txBody>
      </p:sp>
      <p:sp>
        <p:nvSpPr>
          <p:cNvPr id="10" name="テキスト ボックス 9"/>
          <p:cNvSpPr txBox="1"/>
          <p:nvPr/>
        </p:nvSpPr>
        <p:spPr>
          <a:xfrm rot="16200000">
            <a:off x="-9911" y="4703894"/>
            <a:ext cx="15730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Variants numbers /kb 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4150612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73770240"/>
              </p:ext>
            </p:extLst>
          </p:nvPr>
        </p:nvGraphicFramePr>
        <p:xfrm>
          <a:off x="692942" y="1403854"/>
          <a:ext cx="7543800" cy="27538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テキスト ボックス 2"/>
          <p:cNvSpPr txBox="1"/>
          <p:nvPr/>
        </p:nvSpPr>
        <p:spPr>
          <a:xfrm>
            <a:off x="243780" y="1034522"/>
            <a:ext cx="4491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(</a:t>
            </a:r>
            <a:r>
              <a:rPr kumimoji="1" lang="en-US" altLang="ja-JP" dirty="0" smtClean="0"/>
              <a:t>C)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056945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5100" y="279516"/>
            <a:ext cx="3597057" cy="2241361"/>
          </a:xfrm>
          <a:prstGeom prst="rect">
            <a:avLst/>
          </a:prstGeom>
          <a:ln w="28575">
            <a:solidFill>
              <a:schemeClr val="bg1"/>
            </a:solidFill>
          </a:ln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35654" y="2568961"/>
            <a:ext cx="3650389" cy="2021015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55100" y="4736096"/>
            <a:ext cx="3653492" cy="2060675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11818" y="4638060"/>
            <a:ext cx="3472527" cy="2163764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11434" y="0"/>
            <a:ext cx="2537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Supplementary Fig. 2</a:t>
            </a:r>
            <a:endParaRPr kumimoji="1" lang="ja-JP" altLang="en-US" dirty="0"/>
          </a:p>
        </p:txBody>
      </p:sp>
      <p:pic>
        <p:nvPicPr>
          <p:cNvPr id="13" name="図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811818" y="279516"/>
            <a:ext cx="3597057" cy="2241361"/>
          </a:xfrm>
          <a:prstGeom prst="rect">
            <a:avLst/>
          </a:prstGeom>
        </p:spPr>
      </p:pic>
      <p:sp>
        <p:nvSpPr>
          <p:cNvPr id="2" name="テキスト ボックス 1"/>
          <p:cNvSpPr txBox="1"/>
          <p:nvPr/>
        </p:nvSpPr>
        <p:spPr>
          <a:xfrm>
            <a:off x="2227098" y="-44908"/>
            <a:ext cx="2184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/>
              <a:t>(a) </a:t>
            </a:r>
            <a:r>
              <a:rPr lang="en-US" altLang="ja-JP" i="1" dirty="0" smtClean="0"/>
              <a:t>MSH2-EPCAM </a:t>
            </a:r>
            <a:endParaRPr kumimoji="1" lang="ja-JP" altLang="en-US" i="1" dirty="0"/>
          </a:p>
        </p:txBody>
      </p:sp>
      <p:pic>
        <p:nvPicPr>
          <p:cNvPr id="10" name="図 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67181" y="2520877"/>
            <a:ext cx="3555103" cy="22152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16185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05223"/>
            <a:ext cx="4395475" cy="2738862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96906" y="1070537"/>
            <a:ext cx="4185836" cy="2608234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8473" y="4102713"/>
            <a:ext cx="4217002" cy="2627654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96905" y="4102713"/>
            <a:ext cx="4279621" cy="2526687"/>
          </a:xfrm>
          <a:prstGeom prst="rect">
            <a:avLst/>
          </a:prstGeom>
        </p:spPr>
      </p:pic>
      <p:sp>
        <p:nvSpPr>
          <p:cNvPr id="3" name="正方形/長方形 2"/>
          <p:cNvSpPr/>
          <p:nvPr/>
        </p:nvSpPr>
        <p:spPr>
          <a:xfrm>
            <a:off x="221845" y="456577"/>
            <a:ext cx="11095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/>
              <a:t>(b) </a:t>
            </a:r>
            <a:r>
              <a:rPr lang="en-US" altLang="ja-JP" i="1" dirty="0" smtClean="0"/>
              <a:t>MLH1 </a:t>
            </a:r>
            <a:endParaRPr lang="ja-JP" altLang="en-US" i="1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1434" y="0"/>
            <a:ext cx="2537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Supplementary Fig. 2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278959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2635" y="841624"/>
            <a:ext cx="4150053" cy="2585938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18632" y="841624"/>
            <a:ext cx="4211711" cy="2624357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3804" y="3760091"/>
            <a:ext cx="4027714" cy="2509707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18631" y="3760091"/>
            <a:ext cx="4211711" cy="2624357"/>
          </a:xfrm>
          <a:prstGeom prst="rect">
            <a:avLst/>
          </a:prstGeom>
        </p:spPr>
      </p:pic>
      <p:sp>
        <p:nvSpPr>
          <p:cNvPr id="6" name="正方形/長方形 5"/>
          <p:cNvSpPr/>
          <p:nvPr/>
        </p:nvSpPr>
        <p:spPr>
          <a:xfrm>
            <a:off x="172635" y="306028"/>
            <a:ext cx="9012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/>
              <a:t>(c) </a:t>
            </a:r>
            <a:r>
              <a:rPr lang="en-US" altLang="ja-JP" i="1" dirty="0" smtClean="0"/>
              <a:t>APC </a:t>
            </a:r>
            <a:endParaRPr lang="ja-JP" altLang="en-US" i="1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1434" y="0"/>
            <a:ext cx="2537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Supplementary Fig. 2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4624611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</TotalTime>
  <Words>44</Words>
  <Application>Microsoft Office PowerPoint</Application>
  <PresentationFormat>画面に合わせる (4:3)</PresentationFormat>
  <Paragraphs>13</Paragraphs>
  <Slides>5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0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kagawa</dc:creator>
  <cp:lastModifiedBy>Nakagawa</cp:lastModifiedBy>
  <cp:revision>10</cp:revision>
  <dcterms:created xsi:type="dcterms:W3CDTF">2019-12-17T03:20:24Z</dcterms:created>
  <dcterms:modified xsi:type="dcterms:W3CDTF">2020-01-08T10:18:52Z</dcterms:modified>
</cp:coreProperties>
</file>